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21"/>
  </p:notesMasterIdLst>
  <p:sldIdLst>
    <p:sldId id="284" r:id="rId2"/>
    <p:sldId id="285" r:id="rId3"/>
    <p:sldId id="303" r:id="rId4"/>
    <p:sldId id="286" r:id="rId5"/>
    <p:sldId id="302" r:id="rId6"/>
    <p:sldId id="301" r:id="rId7"/>
    <p:sldId id="295" r:id="rId8"/>
    <p:sldId id="291" r:id="rId9"/>
    <p:sldId id="296" r:id="rId10"/>
    <p:sldId id="299" r:id="rId11"/>
    <p:sldId id="293" r:id="rId12"/>
    <p:sldId id="300" r:id="rId13"/>
    <p:sldId id="308" r:id="rId14"/>
    <p:sldId id="275" r:id="rId15"/>
    <p:sldId id="307" r:id="rId16"/>
    <p:sldId id="305" r:id="rId17"/>
    <p:sldId id="306" r:id="rId18"/>
    <p:sldId id="289" r:id="rId19"/>
    <p:sldId id="304" r:id="rId20"/>
  </p:sldIdLst>
  <p:sldSz cx="6858000" cy="10972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853"/>
    <p:restoredTop sz="94860"/>
  </p:normalViewPr>
  <p:slideViewPr>
    <p:cSldViewPr snapToGrid="0">
      <p:cViewPr varScale="1">
        <p:scale>
          <a:sx n="77" d="100"/>
          <a:sy n="77" d="100"/>
        </p:scale>
        <p:origin x="35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9337F3-6D18-894F-B45A-CFADE438C83C}" type="datetimeFigureOut">
              <a:rPr lang="en-US" smtClean="0"/>
              <a:t>11/1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63800" y="1143000"/>
            <a:ext cx="1930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2AAD781-E4BE-EB44-A28F-820682A491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403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AAD781-E4BE-EB44-A28F-820682A4914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3277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795781"/>
            <a:ext cx="5829300" cy="382016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763261"/>
            <a:ext cx="5143500" cy="2649219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0919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776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84200"/>
            <a:ext cx="1478756" cy="929894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84200"/>
            <a:ext cx="4350544" cy="929894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089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623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735583"/>
            <a:ext cx="5915025" cy="456437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7343143"/>
            <a:ext cx="5915025" cy="24002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330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921000"/>
            <a:ext cx="291465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921000"/>
            <a:ext cx="2914650" cy="69621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546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84202"/>
            <a:ext cx="5915025" cy="21209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689861"/>
            <a:ext cx="2901255" cy="131825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008120"/>
            <a:ext cx="2901255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689861"/>
            <a:ext cx="2915543" cy="131825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008120"/>
            <a:ext cx="2915543" cy="58953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536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807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681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31520"/>
            <a:ext cx="2211884" cy="25603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579882"/>
            <a:ext cx="3471863" cy="7797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91840"/>
            <a:ext cx="2211884" cy="609854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516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31520"/>
            <a:ext cx="2211884" cy="256032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579882"/>
            <a:ext cx="3471863" cy="779780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291840"/>
            <a:ext cx="2211884" cy="609854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458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84202"/>
            <a:ext cx="5915025" cy="21209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921000"/>
            <a:ext cx="5915025" cy="69621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10170162"/>
            <a:ext cx="154305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09BC68-BA7B-7443-A496-A27E76304D48}" type="datetimeFigureOut">
              <a:rPr lang="en-US" smtClean="0"/>
              <a:t>11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0170162"/>
            <a:ext cx="2314575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0170162"/>
            <a:ext cx="1543050" cy="5842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58AD079-0F4F-A44F-8668-2AC9A73CBD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950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34B8576-87C5-D79B-6054-6C94CE75C3E2}"/>
              </a:ext>
            </a:extLst>
          </p:cNvPr>
          <p:cNvGraphicFramePr>
            <a:graphicFrameLocks noGrp="1"/>
          </p:cNvGraphicFramePr>
          <p:nvPr/>
        </p:nvGraphicFramePr>
        <p:xfrm>
          <a:off x="919301" y="5486400"/>
          <a:ext cx="2486253" cy="2015726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176448">
                  <a:extLst>
                    <a:ext uri="{9D8B030D-6E8A-4147-A177-3AD203B41FA5}">
                      <a16:colId xmlns:a16="http://schemas.microsoft.com/office/drawing/2014/main" val="2719737720"/>
                    </a:ext>
                  </a:extLst>
                </a:gridCol>
                <a:gridCol w="2309805">
                  <a:extLst>
                    <a:ext uri="{9D8B030D-6E8A-4147-A177-3AD203B41FA5}">
                      <a16:colId xmlns:a16="http://schemas.microsoft.com/office/drawing/2014/main" val="2136527393"/>
                    </a:ext>
                  </a:extLst>
                </a:gridCol>
              </a:tblGrid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A</a:t>
                      </a:r>
                    </a:p>
                  </a:txBody>
                  <a:tcPr marL="6804" marR="6804" marT="6804" marB="0" anchor="b">
                    <a:solidFill>
                      <a:srgbClr val="94219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RNA processing and modifica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967699237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B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C0C0C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chromatin structure and dynamic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567852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C</a:t>
                      </a:r>
                    </a:p>
                  </a:txBody>
                  <a:tcPr marL="6804" marR="6804" marT="6804" marB="0" anchor="b">
                    <a:solidFill>
                      <a:srgbClr val="0096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energy production and conversio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677855874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D</a:t>
                      </a:r>
                    </a:p>
                  </a:txBody>
                  <a:tcPr marL="6804" marR="6804" marT="6804" marB="0" anchor="b">
                    <a:solidFill>
                      <a:srgbClr val="03919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cell cycle control, cell division, chromosome partitionin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717249747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FFF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amino acid transport and metabol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042316756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0EF9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nucleotide transport and metabol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663527173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FF7D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carbohydrate transport and 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1728853433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H</a:t>
                      </a:r>
                    </a:p>
                  </a:txBody>
                  <a:tcPr marL="6804" marR="6804" marT="6804" marB="0" anchor="b">
                    <a:solidFill>
                      <a:srgbClr val="9452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coenzyme transport and 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583849139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FF2E9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lipid transport and metabolis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816270125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FF85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translation, ribosomal structure and biogenesi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102775770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K</a:t>
                      </a:r>
                    </a:p>
                  </a:txBody>
                  <a:tcPr marL="6804" marR="6804" marT="6804" marB="0" anchor="b">
                    <a:solidFill>
                      <a:srgbClr val="4E9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transcripti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907842097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72FE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replication, recombination and repai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2411834442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M</a:t>
                      </a:r>
                    </a:p>
                  </a:txBody>
                  <a:tcPr marL="6804" marR="6804" marT="6804" marB="0" anchor="b">
                    <a:solidFill>
                      <a:srgbClr val="9311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cell wall/membrane/envelope biogenesi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2320964053"/>
                  </a:ext>
                </a:extLst>
              </a:tr>
              <a:tr h="14515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D5FC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cell motilit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4009331775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CEC70C4-93D8-ED52-5093-E23654F5A3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9924246"/>
              </p:ext>
            </p:extLst>
          </p:nvPr>
        </p:nvGraphicFramePr>
        <p:xfrm>
          <a:off x="3405554" y="5486400"/>
          <a:ext cx="2486253" cy="2015720"/>
        </p:xfrm>
        <a:graphic>
          <a:graphicData uri="http://schemas.openxmlformats.org/drawingml/2006/table">
            <a:tbl>
              <a:tblPr>
                <a:tableStyleId>{073A0DAA-6AF3-43AB-8588-CEC1D06C72B9}</a:tableStyleId>
              </a:tblPr>
              <a:tblGrid>
                <a:gridCol w="177120">
                  <a:extLst>
                    <a:ext uri="{9D8B030D-6E8A-4147-A177-3AD203B41FA5}">
                      <a16:colId xmlns:a16="http://schemas.microsoft.com/office/drawing/2014/main" val="1909242617"/>
                    </a:ext>
                  </a:extLst>
                </a:gridCol>
                <a:gridCol w="2309133">
                  <a:extLst>
                    <a:ext uri="{9D8B030D-6E8A-4147-A177-3AD203B41FA5}">
                      <a16:colId xmlns:a16="http://schemas.microsoft.com/office/drawing/2014/main" val="3890098827"/>
                    </a:ext>
                  </a:extLst>
                </a:gridCol>
              </a:tblGrid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O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FFD57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posttranslational modification, protein turnover, chapero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967699237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P</a:t>
                      </a:r>
                    </a:p>
                  </a:txBody>
                  <a:tcPr marL="6804" marR="6804" marT="6804" marB="0" anchor="b">
                    <a:solidFill>
                      <a:srgbClr val="7B81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inorganic ion transport and metabol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567852433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Q</a:t>
                      </a:r>
                    </a:p>
                  </a:txBody>
                  <a:tcPr marL="6804" marR="6804" marT="6804" marB="0" anchor="b">
                    <a:solidFill>
                      <a:srgbClr val="93929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secondary metabolites biosynthesis, transport and cataboli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677855874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R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EBEB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general function prediction onl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717249747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FF94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﻿function unknow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042316756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T</a:t>
                      </a:r>
                    </a:p>
                  </a:txBody>
                  <a:tcPr marL="6804" marR="6804" marT="6804" marB="0" anchor="b">
                    <a:solidFill>
                      <a:srgbClr val="939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signal transduction mechanism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663527173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U</a:t>
                      </a:r>
                    </a:p>
                  </a:txBody>
                  <a:tcPr marL="6804" marR="6804" marT="6804" marB="0" anchor="b">
                    <a:solidFill>
                      <a:srgbClr val="025393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intracellular trafficking, secretion, and vesicular transpor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1728853433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V</a:t>
                      </a:r>
                    </a:p>
                  </a:txBody>
                  <a:tcPr marL="6804" marR="6804" marT="6804" marB="0" anchor="b">
                    <a:solidFill>
                      <a:srgbClr val="94165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defense mechanism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583849139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W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02FB9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extracellular structure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816270125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X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D5D31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mobilome: prophages, transposons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102775770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Y</a:t>
                      </a:r>
                    </a:p>
                  </a:txBody>
                  <a:tcPr marL="6804" marR="6804" marT="6804" marB="0" anchor="b">
                    <a:solidFill>
                      <a:srgbClr val="FF25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nuclear structur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3907842097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Z</a:t>
                      </a:r>
                    </a:p>
                  </a:txBody>
                  <a:tcPr marL="6804" marR="6804" marT="6804" marB="0" anchor="b">
                    <a:solidFill>
                      <a:srgbClr val="038F5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cytoskeleto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2411834442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N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>
                    <a:solidFill>
                      <a:srgbClr val="FFFC78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uncharacterized ge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2320964053"/>
                  </a:ext>
                </a:extLst>
              </a:tr>
              <a:tr h="1439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chemeClr val="bg1">
                              <a:lumMod val="95000"/>
                            </a:schemeClr>
                          </a:solidFill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DIV</a:t>
                      </a:r>
                    </a:p>
                  </a:txBody>
                  <a:tcPr marL="6804" marR="6804" marT="6804" marB="0" anchor="b"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effectLst/>
                          <a:latin typeface="Arial Narrow" panose="020B0604020202020204" pitchFamily="34" charset="0"/>
                          <a:cs typeface="Arial Narrow" panose="020B0604020202020204" pitchFamily="34" charset="0"/>
                        </a:rPr>
                        <a:t>diverse function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 Narrow" panose="020B0604020202020204" pitchFamily="34" charset="0"/>
                        <a:cs typeface="Arial Narrow" panose="020B0604020202020204" pitchFamily="34" charset="0"/>
                      </a:endParaRPr>
                    </a:p>
                  </a:txBody>
                  <a:tcPr marL="6804" marR="6804" marT="6804" marB="0" anchor="b"/>
                </a:tc>
                <a:extLst>
                  <a:ext uri="{0D108BD9-81ED-4DB2-BD59-A6C34878D82A}">
                    <a16:rowId xmlns:a16="http://schemas.microsoft.com/office/drawing/2014/main" val="400933177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4087E70C-2C73-71BB-C926-DDC042C73A36}"/>
              </a:ext>
            </a:extLst>
          </p:cNvPr>
          <p:cNvSpPr txBox="1"/>
          <p:nvPr/>
        </p:nvSpPr>
        <p:spPr>
          <a:xfrm>
            <a:off x="0" y="-3129"/>
            <a:ext cx="2343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2DF484A-D757-BB90-61DD-E9796478E278}"/>
              </a:ext>
            </a:extLst>
          </p:cNvPr>
          <p:cNvSpPr txBox="1"/>
          <p:nvPr/>
        </p:nvSpPr>
        <p:spPr>
          <a:xfrm>
            <a:off x="157462" y="421013"/>
            <a:ext cx="339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A67BBED-BEB1-8C13-109A-DD3773A246D4}"/>
              </a:ext>
            </a:extLst>
          </p:cNvPr>
          <p:cNvSpPr txBox="1"/>
          <p:nvPr/>
        </p:nvSpPr>
        <p:spPr>
          <a:xfrm>
            <a:off x="3429000" y="421013"/>
            <a:ext cx="3397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9" name="Picture 8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287D3911-AC5F-2413-7288-EB1B0C1774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3446" y="605679"/>
            <a:ext cx="6858000" cy="4685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41182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113F47B-9443-E206-3E8D-A39007A0553D}"/>
              </a:ext>
            </a:extLst>
          </p:cNvPr>
          <p:cNvSpPr txBox="1"/>
          <p:nvPr/>
        </p:nvSpPr>
        <p:spPr>
          <a:xfrm>
            <a:off x="0" y="643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9.</a:t>
            </a:r>
          </a:p>
        </p:txBody>
      </p:sp>
      <p:pic>
        <p:nvPicPr>
          <p:cNvPr id="8" name="Picture 7" descr="A screenshot of a graph&#10;&#10;Description automatically generated">
            <a:extLst>
              <a:ext uri="{FF2B5EF4-FFF2-40B4-BE49-F238E27FC236}">
                <a16:creationId xmlns:a16="http://schemas.microsoft.com/office/drawing/2014/main" id="{B5544ADC-AE76-3081-428A-7D4B23C381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79538"/>
            <a:ext cx="6858000" cy="4572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57E50D7-71BF-A165-9D3C-69E7970E1CF8}"/>
              </a:ext>
            </a:extLst>
          </p:cNvPr>
          <p:cNvSpPr txBox="1"/>
          <p:nvPr/>
        </p:nvSpPr>
        <p:spPr>
          <a:xfrm>
            <a:off x="479979" y="979538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UB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D4530A4-5B3C-06E2-C38E-F122BEDBE5C8}"/>
              </a:ext>
            </a:extLst>
          </p:cNvPr>
          <p:cNvSpPr txBox="1"/>
          <p:nvPr/>
        </p:nvSpPr>
        <p:spPr>
          <a:xfrm>
            <a:off x="2326278" y="979538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UB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3F76C7E-3554-42A7-10BE-1070A3DBC651}"/>
              </a:ext>
            </a:extLst>
          </p:cNvPr>
          <p:cNvSpPr txBox="1"/>
          <p:nvPr/>
        </p:nvSpPr>
        <p:spPr>
          <a:xfrm>
            <a:off x="4017546" y="979538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DK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C8C6798-D156-12BB-AC49-9C0512434170}"/>
              </a:ext>
            </a:extLst>
          </p:cNvPr>
          <p:cNvSpPr txBox="1"/>
          <p:nvPr/>
        </p:nvSpPr>
        <p:spPr>
          <a:xfrm>
            <a:off x="5708814" y="979538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HP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C04187-BAA7-5627-45C5-8210BC35F6CC}"/>
              </a:ext>
            </a:extLst>
          </p:cNvPr>
          <p:cNvSpPr txBox="1"/>
          <p:nvPr/>
        </p:nvSpPr>
        <p:spPr>
          <a:xfrm>
            <a:off x="479979" y="2492387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URK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EAF44A-D7D7-540D-3AE1-8B824A1748A9}"/>
              </a:ext>
            </a:extLst>
          </p:cNvPr>
          <p:cNvSpPr txBox="1"/>
          <p:nvPr/>
        </p:nvSpPr>
        <p:spPr>
          <a:xfrm>
            <a:off x="2326277" y="2492387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URK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4A492EF-05D3-A745-8E7F-D21F71508357}"/>
              </a:ext>
            </a:extLst>
          </p:cNvPr>
          <p:cNvSpPr txBox="1"/>
          <p:nvPr/>
        </p:nvSpPr>
        <p:spPr>
          <a:xfrm>
            <a:off x="4014610" y="2492387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CAPD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4B43C75-FDB0-D60E-1EA5-CBE9C75C0BBB}"/>
              </a:ext>
            </a:extLst>
          </p:cNvPr>
          <p:cNvSpPr txBox="1"/>
          <p:nvPr/>
        </p:nvSpPr>
        <p:spPr>
          <a:xfrm>
            <a:off x="5702943" y="2492387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CAPD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CEA589E-6EEB-DE37-5580-274706756144}"/>
              </a:ext>
            </a:extLst>
          </p:cNvPr>
          <p:cNvSpPr txBox="1"/>
          <p:nvPr/>
        </p:nvSpPr>
        <p:spPr>
          <a:xfrm>
            <a:off x="479979" y="4003677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CAPD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7AF811C-17AD-790A-EC4E-F5F67C14357B}"/>
              </a:ext>
            </a:extLst>
          </p:cNvPr>
          <p:cNvSpPr txBox="1"/>
          <p:nvPr/>
        </p:nvSpPr>
        <p:spPr>
          <a:xfrm>
            <a:off x="2326276" y="4003677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OP2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ED35B4D-D9B2-2A7D-24C4-EEF729E1468B}"/>
              </a:ext>
            </a:extLst>
          </p:cNvPr>
          <p:cNvSpPr txBox="1"/>
          <p:nvPr/>
        </p:nvSpPr>
        <p:spPr>
          <a:xfrm>
            <a:off x="4014609" y="4003976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OP2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F4DCCEF-0B40-BAA6-91AF-C8914EAAD668}"/>
              </a:ext>
            </a:extLst>
          </p:cNvPr>
          <p:cNvSpPr txBox="1"/>
          <p:nvPr/>
        </p:nvSpPr>
        <p:spPr>
          <a:xfrm>
            <a:off x="5702942" y="3985990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TCF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6239962-7200-89EA-0822-3E83A55CEEA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9544504"/>
              </p:ext>
            </p:extLst>
          </p:nvPr>
        </p:nvGraphicFramePr>
        <p:xfrm>
          <a:off x="1647687" y="5880090"/>
          <a:ext cx="3562626" cy="26416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084">
                  <a:extLst>
                    <a:ext uri="{9D8B030D-6E8A-4147-A177-3AD203B41FA5}">
                      <a16:colId xmlns:a16="http://schemas.microsoft.com/office/drawing/2014/main" val="3223366978"/>
                    </a:ext>
                  </a:extLst>
                </a:gridCol>
                <a:gridCol w="827084">
                  <a:extLst>
                    <a:ext uri="{9D8B030D-6E8A-4147-A177-3AD203B41FA5}">
                      <a16:colId xmlns:a16="http://schemas.microsoft.com/office/drawing/2014/main" val="2353169901"/>
                    </a:ext>
                  </a:extLst>
                </a:gridCol>
                <a:gridCol w="1908458">
                  <a:extLst>
                    <a:ext uri="{9D8B030D-6E8A-4147-A177-3AD203B41FA5}">
                      <a16:colId xmlns:a16="http://schemas.microsoft.com/office/drawing/2014/main" val="217442789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 Numbe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434413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1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b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6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1530255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49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b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695, AAEL01159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0164041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69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k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pp02757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7843945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2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p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03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4094363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0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rk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988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5834210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4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rk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5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418467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4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apd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889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7719984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1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apd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168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5132682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50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capd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88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831052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43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p2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0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1339648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56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p2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0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20823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9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f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5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439435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2593706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24BD21F-6572-4CA4-6A5E-556781BD7A1E}"/>
              </a:ext>
            </a:extLst>
          </p:cNvPr>
          <p:cNvSpPr txBox="1"/>
          <p:nvPr/>
        </p:nvSpPr>
        <p:spPr>
          <a:xfrm>
            <a:off x="0" y="6432"/>
            <a:ext cx="2698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0.</a:t>
            </a:r>
          </a:p>
        </p:txBody>
      </p:sp>
      <p:pic>
        <p:nvPicPr>
          <p:cNvPr id="3" name="Picture 2" descr="A comparison of a graph&#10;&#10;Description automatically generated with medium confidence">
            <a:extLst>
              <a:ext uri="{FF2B5EF4-FFF2-40B4-BE49-F238E27FC236}">
                <a16:creationId xmlns:a16="http://schemas.microsoft.com/office/drawing/2014/main" id="{954F8B80-7D8C-6BB0-0EC2-7AB29DCC307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7703"/>
          <a:stretch/>
        </p:blipFill>
        <p:spPr>
          <a:xfrm>
            <a:off x="0" y="344986"/>
            <a:ext cx="6858000" cy="3164832"/>
          </a:xfrm>
          <a:prstGeom prst="rect">
            <a:avLst/>
          </a:prstGeom>
        </p:spPr>
      </p:pic>
      <p:pic>
        <p:nvPicPr>
          <p:cNvPr id="4" name="Picture 3" descr="A comparison of a graph&#10;&#10;Description automatically generated with medium confidence">
            <a:extLst>
              <a:ext uri="{FF2B5EF4-FFF2-40B4-BE49-F238E27FC236}">
                <a16:creationId xmlns:a16="http://schemas.microsoft.com/office/drawing/2014/main" id="{3F91C73C-8818-F038-C944-5F526B6172B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7703"/>
          <a:stretch/>
        </p:blipFill>
        <p:spPr>
          <a:xfrm>
            <a:off x="0" y="3505647"/>
            <a:ext cx="6858000" cy="3164832"/>
          </a:xfrm>
          <a:prstGeom prst="rect">
            <a:avLst/>
          </a:prstGeom>
        </p:spPr>
      </p:pic>
      <p:pic>
        <p:nvPicPr>
          <p:cNvPr id="5" name="Picture 4" descr="A comparison of a graph&#10;&#10;Description automatically generated with medium confidence">
            <a:extLst>
              <a:ext uri="{FF2B5EF4-FFF2-40B4-BE49-F238E27FC236}">
                <a16:creationId xmlns:a16="http://schemas.microsoft.com/office/drawing/2014/main" id="{4C2E9FB2-5C3F-05B4-4B97-1CB5356C04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670479"/>
            <a:ext cx="6858000" cy="3429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640623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0C275A3-C130-0BD1-730D-13DED448E1A8}"/>
              </a:ext>
            </a:extLst>
          </p:cNvPr>
          <p:cNvSpPr txBox="1"/>
          <p:nvPr/>
        </p:nvSpPr>
        <p:spPr>
          <a:xfrm>
            <a:off x="0" y="6432"/>
            <a:ext cx="2681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11.</a:t>
            </a:r>
          </a:p>
        </p:txBody>
      </p:sp>
      <p:pic>
        <p:nvPicPr>
          <p:cNvPr id="5" name="Picture 4" descr="A graph of a line graph&#10;&#10;Description automatically generated with medium confidence">
            <a:extLst>
              <a:ext uri="{FF2B5EF4-FFF2-40B4-BE49-F238E27FC236}">
                <a16:creationId xmlns:a16="http://schemas.microsoft.com/office/drawing/2014/main" id="{680B9621-D572-CC44-02C8-86F6CC6D84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11630" b="5580"/>
          <a:stretch/>
        </p:blipFill>
        <p:spPr>
          <a:xfrm>
            <a:off x="165424" y="914401"/>
            <a:ext cx="3256651" cy="2982481"/>
          </a:xfrm>
          <a:prstGeom prst="rect">
            <a:avLst/>
          </a:prstGeom>
        </p:spPr>
      </p:pic>
      <p:pic>
        <p:nvPicPr>
          <p:cNvPr id="7" name="Picture 6" descr="A graph of a line graph&#10;&#10;Description automatically generated">
            <a:extLst>
              <a:ext uri="{FF2B5EF4-FFF2-40B4-BE49-F238E27FC236}">
                <a16:creationId xmlns:a16="http://schemas.microsoft.com/office/drawing/2014/main" id="{3187C579-DB89-C017-AE8C-BDC29423B68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953" r="10468" b="5580"/>
          <a:stretch/>
        </p:blipFill>
        <p:spPr>
          <a:xfrm>
            <a:off x="3429001" y="914401"/>
            <a:ext cx="3043237" cy="298248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BB2E3D2-2E88-D8FD-0018-E806A6B65ABC}"/>
              </a:ext>
            </a:extLst>
          </p:cNvPr>
          <p:cNvSpPr txBox="1"/>
          <p:nvPr/>
        </p:nvSpPr>
        <p:spPr>
          <a:xfrm>
            <a:off x="1668699" y="652791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Klu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B8A3F8E-634D-C30F-81D7-5A1783360E70}"/>
              </a:ext>
            </a:extLst>
          </p:cNvPr>
          <p:cNvSpPr txBox="1"/>
          <p:nvPr/>
        </p:nvSpPr>
        <p:spPr>
          <a:xfrm>
            <a:off x="4544816" y="652791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CNA</a:t>
            </a:r>
          </a:p>
        </p:txBody>
      </p:sp>
      <p:pic>
        <p:nvPicPr>
          <p:cNvPr id="11" name="Picture 10" descr="A graph with green and blue lines&#10;&#10;Description automatically generated">
            <a:extLst>
              <a:ext uri="{FF2B5EF4-FFF2-40B4-BE49-F238E27FC236}">
                <a16:creationId xmlns:a16="http://schemas.microsoft.com/office/drawing/2014/main" id="{C42D2764-11D9-F1DC-E83E-2106C045C31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11442"/>
          <a:stretch/>
        </p:blipFill>
        <p:spPr>
          <a:xfrm>
            <a:off x="165424" y="4073161"/>
            <a:ext cx="3263576" cy="3158760"/>
          </a:xfrm>
          <a:prstGeom prst="rect">
            <a:avLst/>
          </a:prstGeom>
        </p:spPr>
      </p:pic>
      <p:pic>
        <p:nvPicPr>
          <p:cNvPr id="13" name="Picture 12" descr="A graph of a line graph&#10;&#10;Description automatically generated">
            <a:extLst>
              <a:ext uri="{FF2B5EF4-FFF2-40B4-BE49-F238E27FC236}">
                <a16:creationId xmlns:a16="http://schemas.microsoft.com/office/drawing/2014/main" id="{371D5785-846B-8644-DACA-159AE2BF675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212"/>
          <a:stretch/>
        </p:blipFill>
        <p:spPr>
          <a:xfrm>
            <a:off x="3429000" y="4073161"/>
            <a:ext cx="3308888" cy="3158760"/>
          </a:xfrm>
          <a:prstGeom prst="rect">
            <a:avLst/>
          </a:prstGeom>
        </p:spPr>
      </p:pic>
      <p:sp>
        <p:nvSpPr>
          <p:cNvPr id="14" name="Oval 13">
            <a:extLst>
              <a:ext uri="{FF2B5EF4-FFF2-40B4-BE49-F238E27FC236}">
                <a16:creationId xmlns:a16="http://schemas.microsoft.com/office/drawing/2014/main" id="{058B25F7-79A6-1DBF-2D04-51CC9316D8BB}"/>
              </a:ext>
            </a:extLst>
          </p:cNvPr>
          <p:cNvSpPr/>
          <p:nvPr/>
        </p:nvSpPr>
        <p:spPr>
          <a:xfrm>
            <a:off x="6406347" y="5596434"/>
            <a:ext cx="67479" cy="67479"/>
          </a:xfrm>
          <a:prstGeom prst="ellipse">
            <a:avLst/>
          </a:prstGeom>
          <a:solidFill>
            <a:srgbClr val="05B0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2EF358C4-4C50-D1B0-45C5-247093DD9D16}"/>
              </a:ext>
            </a:extLst>
          </p:cNvPr>
          <p:cNvSpPr/>
          <p:nvPr/>
        </p:nvSpPr>
        <p:spPr>
          <a:xfrm>
            <a:off x="6406346" y="5467350"/>
            <a:ext cx="67479" cy="67479"/>
          </a:xfrm>
          <a:prstGeom prst="ellipse">
            <a:avLst/>
          </a:prstGeom>
          <a:solidFill>
            <a:srgbClr val="7CAF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4CAFF66-D673-B698-41C1-100D324FAF3F}"/>
              </a:ext>
            </a:extLst>
          </p:cNvPr>
          <p:cNvSpPr txBox="1"/>
          <p:nvPr/>
        </p:nvSpPr>
        <p:spPr>
          <a:xfrm>
            <a:off x="1668699" y="4084549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OU2F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EC7D9BF-49E0-4844-68E0-0D36F0BBAD04}"/>
              </a:ext>
            </a:extLst>
          </p:cNvPr>
          <p:cNvSpPr txBox="1"/>
          <p:nvPr/>
        </p:nvSpPr>
        <p:spPr>
          <a:xfrm>
            <a:off x="4544816" y="4084549"/>
            <a:ext cx="76106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OX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0E12DA4-8A42-748F-5A6C-55024875F4B9}"/>
              </a:ext>
            </a:extLst>
          </p:cNvPr>
          <p:cNvSpPr txBox="1"/>
          <p:nvPr/>
        </p:nvSpPr>
        <p:spPr>
          <a:xfrm>
            <a:off x="4544816" y="4058747"/>
            <a:ext cx="85151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rospero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CDAD348-6BB7-DE55-1F2B-D8E4973AE39F}"/>
              </a:ext>
            </a:extLst>
          </p:cNvPr>
          <p:cNvSpPr txBox="1"/>
          <p:nvPr/>
        </p:nvSpPr>
        <p:spPr>
          <a:xfrm>
            <a:off x="1623474" y="4078285"/>
            <a:ext cx="70083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ubbin</a:t>
            </a:r>
          </a:p>
        </p:txBody>
      </p:sp>
    </p:spTree>
    <p:extLst>
      <p:ext uri="{BB962C8B-B14F-4D97-AF65-F5344CB8AC3E}">
        <p14:creationId xmlns:p14="http://schemas.microsoft.com/office/powerpoint/2010/main" val="391795928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8C8E114-02D2-A70C-21D4-067F9A5BF941}"/>
              </a:ext>
            </a:extLst>
          </p:cNvPr>
          <p:cNvSpPr txBox="1"/>
          <p:nvPr/>
        </p:nvSpPr>
        <p:spPr>
          <a:xfrm>
            <a:off x="266007" y="249381"/>
            <a:ext cx="26009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 12.</a:t>
            </a:r>
          </a:p>
        </p:txBody>
      </p:sp>
      <p:pic>
        <p:nvPicPr>
          <p:cNvPr id="4" name="Picture 3" descr="A graph of a number of numbers&#10;&#10;Description automatically generated with medium confidence">
            <a:extLst>
              <a:ext uri="{FF2B5EF4-FFF2-40B4-BE49-F238E27FC236}">
                <a16:creationId xmlns:a16="http://schemas.microsoft.com/office/drawing/2014/main" id="{495CBEF9-0A12-18CA-9619-5746AEDEAE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897774"/>
            <a:ext cx="548640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097985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93B5BCB-878A-D858-A977-9B74AABF63DC}"/>
              </a:ext>
            </a:extLst>
          </p:cNvPr>
          <p:cNvSpPr txBox="1"/>
          <p:nvPr/>
        </p:nvSpPr>
        <p:spPr>
          <a:xfrm>
            <a:off x="224836" y="111005"/>
            <a:ext cx="2463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1.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B1E5952-6D49-9055-5497-742AA241B3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0363471"/>
              </p:ext>
            </p:extLst>
          </p:nvPr>
        </p:nvGraphicFramePr>
        <p:xfrm>
          <a:off x="334210" y="665670"/>
          <a:ext cx="3302000" cy="447040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825500">
                  <a:extLst>
                    <a:ext uri="{9D8B030D-6E8A-4147-A177-3AD203B41FA5}">
                      <a16:colId xmlns:a16="http://schemas.microsoft.com/office/drawing/2014/main" val="749161405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860031933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3186195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821269841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 of total</a:t>
                      </a: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7785807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uste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9391496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-like-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565236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748840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-like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705279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/E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5496562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44898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6873625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-like-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9020528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-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372270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6149893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854626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/EB-p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216059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-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9277765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380487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089543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-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9554903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204523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1058267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9412641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-p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5782573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653862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7531781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3553668-2B59-B879-93AE-91B06AA33F29}"/>
              </a:ext>
            </a:extLst>
          </p:cNvPr>
          <p:cNvSpPr txBox="1"/>
          <p:nvPr/>
        </p:nvSpPr>
        <p:spPr>
          <a:xfrm>
            <a:off x="224836" y="111005"/>
            <a:ext cx="2463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2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36DCED0-6361-D41F-688A-3CD0B5275C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266077"/>
              </p:ext>
            </p:extLst>
          </p:nvPr>
        </p:nvGraphicFramePr>
        <p:xfrm>
          <a:off x="471487" y="945403"/>
          <a:ext cx="5915025" cy="2341866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785260">
                  <a:extLst>
                    <a:ext uri="{9D8B030D-6E8A-4147-A177-3AD203B41FA5}">
                      <a16:colId xmlns:a16="http://schemas.microsoft.com/office/drawing/2014/main" val="1966929996"/>
                    </a:ext>
                  </a:extLst>
                </a:gridCol>
                <a:gridCol w="1037988">
                  <a:extLst>
                    <a:ext uri="{9D8B030D-6E8A-4147-A177-3AD203B41FA5}">
                      <a16:colId xmlns:a16="http://schemas.microsoft.com/office/drawing/2014/main" val="1652830785"/>
                    </a:ext>
                  </a:extLst>
                </a:gridCol>
                <a:gridCol w="857468">
                  <a:extLst>
                    <a:ext uri="{9D8B030D-6E8A-4147-A177-3AD203B41FA5}">
                      <a16:colId xmlns:a16="http://schemas.microsoft.com/office/drawing/2014/main" val="2644947287"/>
                    </a:ext>
                  </a:extLst>
                </a:gridCol>
                <a:gridCol w="785260">
                  <a:extLst>
                    <a:ext uri="{9D8B030D-6E8A-4147-A177-3AD203B41FA5}">
                      <a16:colId xmlns:a16="http://schemas.microsoft.com/office/drawing/2014/main" val="657625290"/>
                    </a:ext>
                  </a:extLst>
                </a:gridCol>
                <a:gridCol w="785260">
                  <a:extLst>
                    <a:ext uri="{9D8B030D-6E8A-4147-A177-3AD203B41FA5}">
                      <a16:colId xmlns:a16="http://schemas.microsoft.com/office/drawing/2014/main" val="112751597"/>
                    </a:ext>
                  </a:extLst>
                </a:gridCol>
                <a:gridCol w="878529">
                  <a:extLst>
                    <a:ext uri="{9D8B030D-6E8A-4147-A177-3AD203B41FA5}">
                      <a16:colId xmlns:a16="http://schemas.microsoft.com/office/drawing/2014/main" val="4275590695"/>
                    </a:ext>
                  </a:extLst>
                </a:gridCol>
                <a:gridCol w="785260">
                  <a:extLst>
                    <a:ext uri="{9D8B030D-6E8A-4147-A177-3AD203B41FA5}">
                      <a16:colId xmlns:a16="http://schemas.microsoft.com/office/drawing/2014/main" val="846158628"/>
                    </a:ext>
                  </a:extLst>
                </a:gridCol>
              </a:tblGrid>
              <a:tr h="16900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point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g log</a:t>
                      </a:r>
                      <a:r>
                        <a:rPr lang="en-US" sz="1000" b="1" u="none" strike="noStrike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t.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t.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dj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uster/cell typ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extLst>
                  <a:ext uri="{0D108BD9-81ED-4DB2-BD59-A6C34878D82A}">
                    <a16:rowId xmlns:a16="http://schemas.microsoft.com/office/drawing/2014/main" val="308810860"/>
                  </a:ext>
                </a:extLst>
              </a:tr>
              <a:tr h="169001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1E-2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/EB-p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1230724579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9E-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1608835966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E-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-like-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3830979510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E-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2069639269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E-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4083126720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1E-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-like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1452705308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6E-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377092357"/>
                  </a:ext>
                </a:extLst>
              </a:tr>
              <a:tr h="169001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6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0E-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/EB-p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752750430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E-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/E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850933244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5E-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3521086143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6E-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-like-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1149441905"/>
                  </a:ext>
                </a:extLst>
              </a:tr>
              <a:tr h="1690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E-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054" marR="9054" marT="9054" marB="0" anchor="b"/>
                </a:tc>
                <a:extLst>
                  <a:ext uri="{0D108BD9-81ED-4DB2-BD59-A6C34878D82A}">
                    <a16:rowId xmlns:a16="http://schemas.microsoft.com/office/drawing/2014/main" val="20307290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2387267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51E232C7-32FB-AEFA-4FC4-3C4562AF173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1888483"/>
              </p:ext>
            </p:extLst>
          </p:nvPr>
        </p:nvGraphicFramePr>
        <p:xfrm>
          <a:off x="482138" y="494439"/>
          <a:ext cx="5836826" cy="9993529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633740">
                  <a:extLst>
                    <a:ext uri="{9D8B030D-6E8A-4147-A177-3AD203B41FA5}">
                      <a16:colId xmlns:a16="http://schemas.microsoft.com/office/drawing/2014/main" val="3761312466"/>
                    </a:ext>
                  </a:extLst>
                </a:gridCol>
                <a:gridCol w="835115">
                  <a:extLst>
                    <a:ext uri="{9D8B030D-6E8A-4147-A177-3AD203B41FA5}">
                      <a16:colId xmlns:a16="http://schemas.microsoft.com/office/drawing/2014/main" val="908724957"/>
                    </a:ext>
                  </a:extLst>
                </a:gridCol>
                <a:gridCol w="983301">
                  <a:extLst>
                    <a:ext uri="{9D8B030D-6E8A-4147-A177-3AD203B41FA5}">
                      <a16:colId xmlns:a16="http://schemas.microsoft.com/office/drawing/2014/main" val="1922576228"/>
                    </a:ext>
                  </a:extLst>
                </a:gridCol>
                <a:gridCol w="537304">
                  <a:extLst>
                    <a:ext uri="{9D8B030D-6E8A-4147-A177-3AD203B41FA5}">
                      <a16:colId xmlns:a16="http://schemas.microsoft.com/office/drawing/2014/main" val="2610937757"/>
                    </a:ext>
                  </a:extLst>
                </a:gridCol>
                <a:gridCol w="621586">
                  <a:extLst>
                    <a:ext uri="{9D8B030D-6E8A-4147-A177-3AD203B41FA5}">
                      <a16:colId xmlns:a16="http://schemas.microsoft.com/office/drawing/2014/main" val="4060616853"/>
                    </a:ext>
                  </a:extLst>
                </a:gridCol>
                <a:gridCol w="621586">
                  <a:extLst>
                    <a:ext uri="{9D8B030D-6E8A-4147-A177-3AD203B41FA5}">
                      <a16:colId xmlns:a16="http://schemas.microsoft.com/office/drawing/2014/main" val="1305466926"/>
                    </a:ext>
                  </a:extLst>
                </a:gridCol>
                <a:gridCol w="999345">
                  <a:extLst>
                    <a:ext uri="{9D8B030D-6E8A-4147-A177-3AD203B41FA5}">
                      <a16:colId xmlns:a16="http://schemas.microsoft.com/office/drawing/2014/main" val="1634274859"/>
                    </a:ext>
                  </a:extLst>
                </a:gridCol>
                <a:gridCol w="604849">
                  <a:extLst>
                    <a:ext uri="{9D8B030D-6E8A-4147-A177-3AD203B41FA5}">
                      <a16:colId xmlns:a16="http://schemas.microsoft.com/office/drawing/2014/main" val="117184729"/>
                    </a:ext>
                  </a:extLst>
                </a:gridCol>
              </a:tblGrid>
              <a:tr h="19752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poin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US" sz="900" b="1" u="none" strike="noStrike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dj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947959417"/>
                  </a:ext>
                </a:extLst>
              </a:tr>
              <a:tr h="158000">
                <a:tc rowSpan="14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14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E-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6E-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132363712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3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E-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6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4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KP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658432513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5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5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6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8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856074281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9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1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0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DP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285752816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6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8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411551222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7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4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98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093014923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74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9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4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1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GK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241788635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-nbis-gene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0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668812079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6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7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2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07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419614645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9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2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96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279116156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68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2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39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56749412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5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68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6a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158269339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6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2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4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0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70471810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9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29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1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51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739413473"/>
                  </a:ext>
                </a:extLst>
              </a:tr>
              <a:tr h="158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2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E-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8E-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633709543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44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9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6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6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461135600"/>
                  </a:ext>
                </a:extLst>
              </a:tr>
              <a:tr h="158000">
                <a:tc rowSpan="24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24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-like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6E-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6E-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937166049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6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1E-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0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90934899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0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0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7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5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t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277155781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3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0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4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YKP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781740502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3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1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3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PLA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812500088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7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9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9654201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0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0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15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PHS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200387133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7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8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29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HL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197613113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9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6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372.F4WEV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822144063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3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0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74259134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1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3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7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3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744837712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0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1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367898278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5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1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1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38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667938156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1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43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9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PIJ0074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269412309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0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3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218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883853017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9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7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1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7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12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PX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580780732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2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86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8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60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AA11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45371361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0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0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3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85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448417108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6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3E-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4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1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MO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409512574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8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70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9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0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780957693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3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2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5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27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60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AA11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156481676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1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45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0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109547995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5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6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7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598798029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0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3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375165401"/>
                  </a:ext>
                </a:extLst>
              </a:tr>
              <a:tr h="158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C-like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6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E-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9E-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653242885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9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6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28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99558989"/>
                  </a:ext>
                </a:extLst>
              </a:tr>
              <a:tr h="158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54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E-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4E-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787573281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7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8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0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7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6381789"/>
                  </a:ext>
                </a:extLst>
              </a:tr>
              <a:tr h="1580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5E-2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2E-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008183906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7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7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33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P2L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773268974"/>
                  </a:ext>
                </a:extLst>
              </a:tr>
              <a:tr h="15800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05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498143837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8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1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3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4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155786160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8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26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0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670774806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4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3.6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14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1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8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203445122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0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5.63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1E-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057950175"/>
                  </a:ext>
                </a:extLst>
              </a:tr>
              <a:tr h="1580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5E-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4E-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851026558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3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1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5E-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8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67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2820809590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0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.4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3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69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755126808"/>
                  </a:ext>
                </a:extLst>
              </a:tr>
              <a:tr h="158000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/E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32512" marR="132512" marT="66256" marB="66256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9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E-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E-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964588248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6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0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6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LN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870800326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8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2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2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86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58176696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7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663596471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9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71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4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13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IP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124164868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9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8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1213628119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2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7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6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56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4036186305"/>
                  </a:ext>
                </a:extLst>
              </a:tr>
              <a:tr h="1580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86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5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E-0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E-0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875" marR="9875" marT="9875" marB="0" anchor="b"/>
                </a:tc>
                <a:extLst>
                  <a:ext uri="{0D108BD9-81ED-4DB2-BD59-A6C34878D82A}">
                    <a16:rowId xmlns:a16="http://schemas.microsoft.com/office/drawing/2014/main" val="3207828466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C1446C81-5D18-8F3E-3C63-AB16B55C2938}"/>
              </a:ext>
            </a:extLst>
          </p:cNvPr>
          <p:cNvSpPr txBox="1"/>
          <p:nvPr/>
        </p:nvSpPr>
        <p:spPr>
          <a:xfrm>
            <a:off x="129300" y="56413"/>
            <a:ext cx="2463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3.</a:t>
            </a:r>
          </a:p>
        </p:txBody>
      </p:sp>
    </p:spTree>
    <p:extLst>
      <p:ext uri="{BB962C8B-B14F-4D97-AF65-F5344CB8AC3E}">
        <p14:creationId xmlns:p14="http://schemas.microsoft.com/office/powerpoint/2010/main" val="171037240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943A157-5828-17CE-2A93-C93D602C79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4481575"/>
              </p:ext>
            </p:extLst>
          </p:nvPr>
        </p:nvGraphicFramePr>
        <p:xfrm>
          <a:off x="444654" y="573050"/>
          <a:ext cx="5968691" cy="9963158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618494">
                  <a:extLst>
                    <a:ext uri="{9D8B030D-6E8A-4147-A177-3AD203B41FA5}">
                      <a16:colId xmlns:a16="http://schemas.microsoft.com/office/drawing/2014/main" val="4134953424"/>
                    </a:ext>
                  </a:extLst>
                </a:gridCol>
                <a:gridCol w="959591">
                  <a:extLst>
                    <a:ext uri="{9D8B030D-6E8A-4147-A177-3AD203B41FA5}">
                      <a16:colId xmlns:a16="http://schemas.microsoft.com/office/drawing/2014/main" val="828245003"/>
                    </a:ext>
                  </a:extLst>
                </a:gridCol>
                <a:gridCol w="965941">
                  <a:extLst>
                    <a:ext uri="{9D8B030D-6E8A-4147-A177-3AD203B41FA5}">
                      <a16:colId xmlns:a16="http://schemas.microsoft.com/office/drawing/2014/main" val="4099377270"/>
                    </a:ext>
                  </a:extLst>
                </a:gridCol>
                <a:gridCol w="527818">
                  <a:extLst>
                    <a:ext uri="{9D8B030D-6E8A-4147-A177-3AD203B41FA5}">
                      <a16:colId xmlns:a16="http://schemas.microsoft.com/office/drawing/2014/main" val="2527703470"/>
                    </a:ext>
                  </a:extLst>
                </a:gridCol>
                <a:gridCol w="610613">
                  <a:extLst>
                    <a:ext uri="{9D8B030D-6E8A-4147-A177-3AD203B41FA5}">
                      <a16:colId xmlns:a16="http://schemas.microsoft.com/office/drawing/2014/main" val="4255556102"/>
                    </a:ext>
                  </a:extLst>
                </a:gridCol>
                <a:gridCol w="610613">
                  <a:extLst>
                    <a:ext uri="{9D8B030D-6E8A-4147-A177-3AD203B41FA5}">
                      <a16:colId xmlns:a16="http://schemas.microsoft.com/office/drawing/2014/main" val="1253480816"/>
                    </a:ext>
                  </a:extLst>
                </a:gridCol>
                <a:gridCol w="1027776">
                  <a:extLst>
                    <a:ext uri="{9D8B030D-6E8A-4147-A177-3AD203B41FA5}">
                      <a16:colId xmlns:a16="http://schemas.microsoft.com/office/drawing/2014/main" val="178837343"/>
                    </a:ext>
                  </a:extLst>
                </a:gridCol>
                <a:gridCol w="647845">
                  <a:extLst>
                    <a:ext uri="{9D8B030D-6E8A-4147-A177-3AD203B41FA5}">
                      <a16:colId xmlns:a16="http://schemas.microsoft.com/office/drawing/2014/main" val="1097744067"/>
                    </a:ext>
                  </a:extLst>
                </a:gridCol>
              </a:tblGrid>
              <a:tr h="1888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point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US" sz="900" b="1" u="none" strike="noStrike" baseline="-25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dj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006512142"/>
                  </a:ext>
                </a:extLst>
              </a:tr>
              <a:tr h="160235">
                <a:tc rowSpan="24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8974" marR="128974" marT="64487" marB="64487" anchor="ctr"/>
                </a:tc>
                <a:tc rowSpan="24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/E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8974" marR="128974" marT="64487" marB="64487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6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8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86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862401766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6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49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4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66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694723609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7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0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5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6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7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739174480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6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34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034465997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4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6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8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722391493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6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7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2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17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4008577889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2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8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388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NRNPH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656808035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9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3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2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372.F4WEV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405762524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29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0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3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19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3G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660189292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2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0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6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37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C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741384110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4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3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68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5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05759415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5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9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30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403506766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3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3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4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00476781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0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3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1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27182924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4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30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031082542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7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2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33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HP2L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587814060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8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0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733561520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4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2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38435117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5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2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3372.F4WQG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010622073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9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2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7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633199779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9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3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3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65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901873541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0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3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8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7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57813374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3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70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0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607644187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3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9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4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96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NAA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928836133"/>
                  </a:ext>
                </a:extLst>
              </a:tr>
              <a:tr h="160235">
                <a:tc rowSpan="26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8974" marR="128974" marT="64487" marB="64487" anchor="ctr"/>
                </a:tc>
                <a:tc rowSpan="26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C/EB-prol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8974" marR="128974" marT="64487" marB="64487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3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7E-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58E-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18240100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44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8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0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732688831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9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353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27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502541235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3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6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3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81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675299403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0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1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394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6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210800562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7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3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5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50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1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78308053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1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983822232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6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6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5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079930012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4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40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3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87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60000434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92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7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0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410516397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2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4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56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543863907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6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868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1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923431712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1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073904831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8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6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88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8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4237014414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5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9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0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30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976785066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0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6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58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6l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163727166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7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3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10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6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7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952331764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44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7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7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884802569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8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0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3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192767921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5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6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38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198138054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6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9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3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17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736630579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4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6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0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2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1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802801057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4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8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5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1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5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1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42629401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3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8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4E-0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492507310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0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9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7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1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05234213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55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9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8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757016292"/>
                  </a:ext>
                </a:extLst>
              </a:tr>
              <a:tr h="160235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8974" marR="128974" marT="64487" marB="64487" anchor="ctr"/>
                </a:tc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-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8974" marR="128974" marT="64487" marB="64487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2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8E-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0E-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56144137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4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8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72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489167193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1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7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994096443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7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6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37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938794551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5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7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309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4290923371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0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79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4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1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790086055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6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89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5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0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175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810092327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28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6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6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9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8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L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2205995634"/>
                  </a:ext>
                </a:extLst>
              </a:tr>
              <a:tr h="16023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8974" marR="128974" marT="64487" marB="64487" anchor="ctr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M-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28974" marR="128974" marT="64487" marB="64487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65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44E-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2E-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28662789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2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5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8E-0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0E-0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6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1267756578"/>
                  </a:ext>
                </a:extLst>
              </a:tr>
              <a:tr h="16023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4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0E-0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1E-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6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AB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765" marR="9765" marT="9765" marB="0" anchor="b"/>
                </a:tc>
                <a:extLst>
                  <a:ext uri="{0D108BD9-81ED-4DB2-BD59-A6C34878D82A}">
                    <a16:rowId xmlns:a16="http://schemas.microsoft.com/office/drawing/2014/main" val="359127800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93849428-F89F-E169-3D5D-869BA5214E93}"/>
              </a:ext>
            </a:extLst>
          </p:cNvPr>
          <p:cNvSpPr txBox="1"/>
          <p:nvPr/>
        </p:nvSpPr>
        <p:spPr>
          <a:xfrm>
            <a:off x="129300" y="56413"/>
            <a:ext cx="31813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3. (cont.)</a:t>
            </a:r>
          </a:p>
        </p:txBody>
      </p:sp>
    </p:spTree>
    <p:extLst>
      <p:ext uri="{BB962C8B-B14F-4D97-AF65-F5344CB8AC3E}">
        <p14:creationId xmlns:p14="http://schemas.microsoft.com/office/powerpoint/2010/main" val="8613150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E984F1C-E8F5-D685-1C62-20050AD38D9F}"/>
              </a:ext>
            </a:extLst>
          </p:cNvPr>
          <p:cNvSpPr txBox="1"/>
          <p:nvPr/>
        </p:nvSpPr>
        <p:spPr>
          <a:xfrm>
            <a:off x="0" y="6432"/>
            <a:ext cx="2591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4.1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D5FF933-FD3C-F863-6F5C-B8C417DB7A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3880572"/>
              </p:ext>
            </p:extLst>
          </p:nvPr>
        </p:nvGraphicFramePr>
        <p:xfrm>
          <a:off x="1104242" y="4087950"/>
          <a:ext cx="4801597" cy="5905493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330200">
                  <a:extLst>
                    <a:ext uri="{9D8B030D-6E8A-4147-A177-3AD203B41FA5}">
                      <a16:colId xmlns:a16="http://schemas.microsoft.com/office/drawing/2014/main" val="3476804532"/>
                    </a:ext>
                  </a:extLst>
                </a:gridCol>
                <a:gridCol w="552450">
                  <a:extLst>
                    <a:ext uri="{9D8B030D-6E8A-4147-A177-3AD203B41FA5}">
                      <a16:colId xmlns:a16="http://schemas.microsoft.com/office/drawing/2014/main" val="1683545783"/>
                    </a:ext>
                  </a:extLst>
                </a:gridCol>
                <a:gridCol w="679450">
                  <a:extLst>
                    <a:ext uri="{9D8B030D-6E8A-4147-A177-3AD203B41FA5}">
                      <a16:colId xmlns:a16="http://schemas.microsoft.com/office/drawing/2014/main" val="2604506184"/>
                    </a:ext>
                  </a:extLst>
                </a:gridCol>
                <a:gridCol w="825500">
                  <a:extLst>
                    <a:ext uri="{9D8B030D-6E8A-4147-A177-3AD203B41FA5}">
                      <a16:colId xmlns:a16="http://schemas.microsoft.com/office/drawing/2014/main" val="4220205118"/>
                    </a:ext>
                  </a:extLst>
                </a:gridCol>
                <a:gridCol w="267697">
                  <a:extLst>
                    <a:ext uri="{9D8B030D-6E8A-4147-A177-3AD203B41FA5}">
                      <a16:colId xmlns:a16="http://schemas.microsoft.com/office/drawing/2014/main" val="1075870849"/>
                    </a:ext>
                  </a:extLst>
                </a:gridCol>
                <a:gridCol w="450850">
                  <a:extLst>
                    <a:ext uri="{9D8B030D-6E8A-4147-A177-3AD203B41FA5}">
                      <a16:colId xmlns:a16="http://schemas.microsoft.com/office/drawing/2014/main" val="3556802222"/>
                    </a:ext>
                  </a:extLst>
                </a:gridCol>
                <a:gridCol w="1695450">
                  <a:extLst>
                    <a:ext uri="{9D8B030D-6E8A-4147-A177-3AD203B41FA5}">
                      <a16:colId xmlns:a16="http://schemas.microsoft.com/office/drawing/2014/main" val="1845202076"/>
                    </a:ext>
                  </a:extLst>
                </a:gridCol>
              </a:tblGrid>
              <a:tr h="2158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I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8373201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V 5' 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840426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X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469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5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criptional regulato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4914963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53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0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chrome p45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1518794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42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963230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V 5’ UTR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9516643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STE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863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81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thione S-transfer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4073414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O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7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98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MN-dependent dehydrogen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0084247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TL2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280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4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sine methyltransfer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324627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7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4392618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6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40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ofil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0151378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X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05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63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meo-prospero doma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92894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58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823707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0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521643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OS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59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20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oporphyrinogen-III synth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71746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26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298660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0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4374216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A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8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28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Type le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2631114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70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3259716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206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46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9065839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510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11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ypsin-like serine prote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2784318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571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47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 dependent lig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384553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DH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458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01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hydrodiol dehydrogen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405014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46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75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tochrome P4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2814682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pS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77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82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tochondrial ribosomal prote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9602595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67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25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utathione S-transfer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9393899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Kov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30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6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6220325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41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679792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24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87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do/keto reductase famil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560917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65D03A7-3029-CFF7-697D-925E2949B2F6}"/>
              </a:ext>
            </a:extLst>
          </p:cNvPr>
          <p:cNvSpPr txBox="1"/>
          <p:nvPr/>
        </p:nvSpPr>
        <p:spPr>
          <a:xfrm>
            <a:off x="0" y="3584007"/>
            <a:ext cx="2591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4.2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ADF6F4A-8E60-9571-6410-1BBCC555A1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026948"/>
              </p:ext>
            </p:extLst>
          </p:nvPr>
        </p:nvGraphicFramePr>
        <p:xfrm>
          <a:off x="299259" y="427646"/>
          <a:ext cx="6239336" cy="302175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668764">
                  <a:extLst>
                    <a:ext uri="{9D8B030D-6E8A-4147-A177-3AD203B41FA5}">
                      <a16:colId xmlns:a16="http://schemas.microsoft.com/office/drawing/2014/main" val="2552054001"/>
                    </a:ext>
                  </a:extLst>
                </a:gridCol>
                <a:gridCol w="825166">
                  <a:extLst>
                    <a:ext uri="{9D8B030D-6E8A-4147-A177-3AD203B41FA5}">
                      <a16:colId xmlns:a16="http://schemas.microsoft.com/office/drawing/2014/main" val="3609390058"/>
                    </a:ext>
                  </a:extLst>
                </a:gridCol>
                <a:gridCol w="668764">
                  <a:extLst>
                    <a:ext uri="{9D8B030D-6E8A-4147-A177-3AD203B41FA5}">
                      <a16:colId xmlns:a16="http://schemas.microsoft.com/office/drawing/2014/main" val="3315355058"/>
                    </a:ext>
                  </a:extLst>
                </a:gridCol>
                <a:gridCol w="668764">
                  <a:extLst>
                    <a:ext uri="{9D8B030D-6E8A-4147-A177-3AD203B41FA5}">
                      <a16:colId xmlns:a16="http://schemas.microsoft.com/office/drawing/2014/main" val="2605598195"/>
                    </a:ext>
                  </a:extLst>
                </a:gridCol>
                <a:gridCol w="668764">
                  <a:extLst>
                    <a:ext uri="{9D8B030D-6E8A-4147-A177-3AD203B41FA5}">
                      <a16:colId xmlns:a16="http://schemas.microsoft.com/office/drawing/2014/main" val="3336064320"/>
                    </a:ext>
                  </a:extLst>
                </a:gridCol>
                <a:gridCol w="668764">
                  <a:extLst>
                    <a:ext uri="{9D8B030D-6E8A-4147-A177-3AD203B41FA5}">
                      <a16:colId xmlns:a16="http://schemas.microsoft.com/office/drawing/2014/main" val="1881808411"/>
                    </a:ext>
                  </a:extLst>
                </a:gridCol>
                <a:gridCol w="2070350">
                  <a:extLst>
                    <a:ext uri="{9D8B030D-6E8A-4147-A177-3AD203B41FA5}">
                      <a16:colId xmlns:a16="http://schemas.microsoft.com/office/drawing/2014/main" val="1532668356"/>
                    </a:ext>
                  </a:extLst>
                </a:gridCol>
              </a:tblGrid>
              <a:tr h="15986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point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</a:t>
                      </a:r>
                      <a:r>
                        <a:rPr lang="en-US" sz="900" b="1" u="none" strike="noStrike" baseline="-25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C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dj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script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4112104986"/>
                  </a:ext>
                </a:extLst>
              </a:tr>
              <a:tr h="151324">
                <a:tc rowSpan="7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63368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7E-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3263233093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5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37596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063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8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mocysteine S-methyltransferase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927808454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31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73858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8269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746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AS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do/keto reductase fami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685634211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28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8863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5723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8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A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Type le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3569872728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7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29622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16105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1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E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bohydrate-binding module 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2377227911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8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55341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28574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796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longs to the peptidase S1 fami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3917737789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0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877734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97722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1863066103"/>
                  </a:ext>
                </a:extLst>
              </a:tr>
              <a:tr h="152721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dpi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bis-gene-2-ut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464541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3E-2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1666518630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4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13131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49E-0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64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A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 heat shock protein (HSP20) fami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2205388205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7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7.49812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28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rinogen and fibronect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2037482180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44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75773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7E-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1456106287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41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53437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E-0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18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L domain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3364006784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43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36519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2317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6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A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 heat shock protein (HSP20) fami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2702317633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42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945449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853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6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A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 heat shock protein (HSP20) fami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109457470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05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59943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03902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321205010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43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452473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9281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64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AB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all heat shock protein (HSP20) famil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1276443735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86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37179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9926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73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itin-binding domain type 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4004537898"/>
                  </a:ext>
                </a:extLst>
              </a:tr>
              <a:tr h="15986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29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447640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99268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3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494" marR="7494" marT="7494" marB="0" anchor="b"/>
                </a:tc>
                <a:extLst>
                  <a:ext uri="{0D108BD9-81ED-4DB2-BD59-A6C34878D82A}">
                    <a16:rowId xmlns:a16="http://schemas.microsoft.com/office/drawing/2014/main" val="24150122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6822516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55C1969-B12D-039F-808E-FFA97ED323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4598759"/>
              </p:ext>
            </p:extLst>
          </p:nvPr>
        </p:nvGraphicFramePr>
        <p:xfrm>
          <a:off x="2391523" y="706113"/>
          <a:ext cx="2154328" cy="3044379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697583">
                  <a:extLst>
                    <a:ext uri="{9D8B030D-6E8A-4147-A177-3AD203B41FA5}">
                      <a16:colId xmlns:a16="http://schemas.microsoft.com/office/drawing/2014/main" val="3476804532"/>
                    </a:ext>
                  </a:extLst>
                </a:gridCol>
                <a:gridCol w="688395">
                  <a:extLst>
                    <a:ext uri="{9D8B030D-6E8A-4147-A177-3AD203B41FA5}">
                      <a16:colId xmlns:a16="http://schemas.microsoft.com/office/drawing/2014/main" val="1683545783"/>
                    </a:ext>
                  </a:extLst>
                </a:gridCol>
                <a:gridCol w="768350">
                  <a:extLst>
                    <a:ext uri="{9D8B030D-6E8A-4147-A177-3AD203B41FA5}">
                      <a16:colId xmlns:a16="http://schemas.microsoft.com/office/drawing/2014/main" val="2604506184"/>
                    </a:ext>
                  </a:extLst>
                </a:gridCol>
              </a:tblGrid>
              <a:tr h="1995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8373201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50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ME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741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8404263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62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NOS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155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4914963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32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D8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854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1518794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34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D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89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8963230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0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O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89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89516643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2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2d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174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4073414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4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969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0084247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09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tus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77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324627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11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RCH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901</a:t>
                      </a:r>
                      <a:endParaRPr lang="en-US" sz="9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0151378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89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AS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UM62642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5928942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91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MO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506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823707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45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SC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73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521643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98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WI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27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71746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94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099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4374216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1E838E9-4FE3-1E92-970D-DD48D0B0F82C}"/>
              </a:ext>
            </a:extLst>
          </p:cNvPr>
          <p:cNvSpPr txBox="1"/>
          <p:nvPr/>
        </p:nvSpPr>
        <p:spPr>
          <a:xfrm>
            <a:off x="0" y="6432"/>
            <a:ext cx="24632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Table 5.</a:t>
            </a:r>
          </a:p>
        </p:txBody>
      </p:sp>
    </p:spTree>
    <p:extLst>
      <p:ext uri="{BB962C8B-B14F-4D97-AF65-F5344CB8AC3E}">
        <p14:creationId xmlns:p14="http://schemas.microsoft.com/office/powerpoint/2010/main" val="13362851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video game&#10;&#10;Description automatically generated">
            <a:extLst>
              <a:ext uri="{FF2B5EF4-FFF2-40B4-BE49-F238E27FC236}">
                <a16:creationId xmlns:a16="http://schemas.microsoft.com/office/drawing/2014/main" id="{A515592E-312F-EFF1-8F45-18274A4879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2446" y="674002"/>
            <a:ext cx="4437508" cy="4996305"/>
          </a:xfrm>
          <a:prstGeom prst="rect">
            <a:avLst/>
          </a:prstGeom>
        </p:spPr>
      </p:pic>
      <p:pic>
        <p:nvPicPr>
          <p:cNvPr id="21" name="Picture 20" descr="A group of images of different colors&#10;&#10;Description automatically generated">
            <a:extLst>
              <a:ext uri="{FF2B5EF4-FFF2-40B4-BE49-F238E27FC236}">
                <a16:creationId xmlns:a16="http://schemas.microsoft.com/office/drawing/2014/main" id="{BFC6C126-5721-624E-8A78-DB4125F83F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2266" y="5616028"/>
            <a:ext cx="6613729" cy="505755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B24FCF7-A4B2-FA01-2726-24E358A62FE7}"/>
              </a:ext>
            </a:extLst>
          </p:cNvPr>
          <p:cNvSpPr txBox="1"/>
          <p:nvPr/>
        </p:nvSpPr>
        <p:spPr>
          <a:xfrm>
            <a:off x="-1380" y="-18327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9827798-096C-6934-3D2A-EAF17FD0C8C8}"/>
              </a:ext>
            </a:extLst>
          </p:cNvPr>
          <p:cNvSpPr txBox="1"/>
          <p:nvPr/>
        </p:nvSpPr>
        <p:spPr>
          <a:xfrm>
            <a:off x="1486539" y="47448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D91AF3C-B3D5-5939-67FB-69FE8136BF3D}"/>
              </a:ext>
            </a:extLst>
          </p:cNvPr>
          <p:cNvSpPr txBox="1"/>
          <p:nvPr/>
        </p:nvSpPr>
        <p:spPr>
          <a:xfrm>
            <a:off x="1486539" y="286058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974E1B-1D19-1AFC-6124-94CC91FED6AC}"/>
              </a:ext>
            </a:extLst>
          </p:cNvPr>
          <p:cNvSpPr txBox="1"/>
          <p:nvPr/>
        </p:nvSpPr>
        <p:spPr>
          <a:xfrm>
            <a:off x="192266" y="559826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A31A90F-C0AE-62BF-3826-2781D147AC68}"/>
              </a:ext>
            </a:extLst>
          </p:cNvPr>
          <p:cNvSpPr txBox="1"/>
          <p:nvPr/>
        </p:nvSpPr>
        <p:spPr>
          <a:xfrm>
            <a:off x="3428999" y="559826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6A2E050-EE9F-55CC-C9D5-C4B52723652C}"/>
              </a:ext>
            </a:extLst>
          </p:cNvPr>
          <p:cNvSpPr txBox="1"/>
          <p:nvPr/>
        </p:nvSpPr>
        <p:spPr>
          <a:xfrm rot="16200000">
            <a:off x="-108941" y="6832699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dpi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37BA1CE-CFA9-F1DB-98B0-DDD119753AB8}"/>
              </a:ext>
            </a:extLst>
          </p:cNvPr>
          <p:cNvSpPr txBox="1"/>
          <p:nvPr/>
        </p:nvSpPr>
        <p:spPr>
          <a:xfrm rot="16200000">
            <a:off x="-157253" y="9052562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2dpi</a:t>
            </a:r>
          </a:p>
        </p:txBody>
      </p:sp>
    </p:spTree>
    <p:extLst>
      <p:ext uri="{BB962C8B-B14F-4D97-AF65-F5344CB8AC3E}">
        <p14:creationId xmlns:p14="http://schemas.microsoft.com/office/powerpoint/2010/main" val="13622104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A5588DC-D027-F29B-FEEE-4FFAC72866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4400" y="457200"/>
            <a:ext cx="5029200" cy="100584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D969C64-62CF-8C6B-713D-9C1502B1875B}"/>
              </a:ext>
            </a:extLst>
          </p:cNvPr>
          <p:cNvSpPr txBox="1"/>
          <p:nvPr/>
        </p:nvSpPr>
        <p:spPr>
          <a:xfrm>
            <a:off x="0" y="87868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177CB2-E677-85E1-B3EB-F12791DF49A3}"/>
              </a:ext>
            </a:extLst>
          </p:cNvPr>
          <p:cNvSpPr txBox="1"/>
          <p:nvPr/>
        </p:nvSpPr>
        <p:spPr>
          <a:xfrm rot="16200000">
            <a:off x="-224221" y="5332510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pression Level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8922EB2-E1E1-748B-A634-9D882812E537}"/>
              </a:ext>
            </a:extLst>
          </p:cNvPr>
          <p:cNvSpPr txBox="1"/>
          <p:nvPr/>
        </p:nvSpPr>
        <p:spPr>
          <a:xfrm>
            <a:off x="550190" y="46232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327340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E4F25A0D-EB3B-E1DE-7EEC-7B6C7C40F53E}"/>
              </a:ext>
            </a:extLst>
          </p:cNvPr>
          <p:cNvSpPr txBox="1"/>
          <p:nvPr/>
        </p:nvSpPr>
        <p:spPr>
          <a:xfrm rot="16200000">
            <a:off x="-286214" y="3348726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pression Leve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624AE43-4033-8096-037D-383519C3DFB2}"/>
              </a:ext>
            </a:extLst>
          </p:cNvPr>
          <p:cNvSpPr txBox="1"/>
          <p:nvPr/>
        </p:nvSpPr>
        <p:spPr>
          <a:xfrm>
            <a:off x="554294" y="38329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6BB7217-53DD-27F5-74A8-B6A9F2B291B7}"/>
              </a:ext>
            </a:extLst>
          </p:cNvPr>
          <p:cNvSpPr txBox="1"/>
          <p:nvPr/>
        </p:nvSpPr>
        <p:spPr>
          <a:xfrm>
            <a:off x="3205934" y="3832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" name="Picture 2" descr="A diagram of a variety of numbers&#10;&#10;Description automatically generated with medium confidence">
            <a:extLst>
              <a:ext uri="{FF2B5EF4-FFF2-40B4-BE49-F238E27FC236}">
                <a16:creationId xmlns:a16="http://schemas.microsoft.com/office/drawing/2014/main" id="{63D32924-70C4-DEA5-9E17-E9D147EB19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0616" y="533166"/>
            <a:ext cx="2514029" cy="10105002"/>
          </a:xfrm>
          <a:prstGeom prst="rect">
            <a:avLst/>
          </a:prstGeom>
        </p:spPr>
      </p:pic>
      <p:pic>
        <p:nvPicPr>
          <p:cNvPr id="5" name="Picture 4" descr="A graph of different types of plants&#10;&#10;Description automatically generated with medium confidence">
            <a:extLst>
              <a:ext uri="{FF2B5EF4-FFF2-40B4-BE49-F238E27FC236}">
                <a16:creationId xmlns:a16="http://schemas.microsoft.com/office/drawing/2014/main" id="{5F36F93B-668A-2D0E-B002-3990EB517B8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1207" y="555002"/>
            <a:ext cx="2516368" cy="578764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CC1B159-0ED8-7CCE-83DB-DA3D67542B69}"/>
              </a:ext>
            </a:extLst>
          </p:cNvPr>
          <p:cNvSpPr txBox="1"/>
          <p:nvPr/>
        </p:nvSpPr>
        <p:spPr>
          <a:xfrm>
            <a:off x="0" y="20633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9052BB4-369F-E8F2-4476-D4BFBB9C479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3672530"/>
              </p:ext>
            </p:extLst>
          </p:nvPr>
        </p:nvGraphicFramePr>
        <p:xfrm>
          <a:off x="438594" y="6535926"/>
          <a:ext cx="2857500" cy="40481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5922">
                  <a:extLst>
                    <a:ext uri="{9D8B030D-6E8A-4147-A177-3AD203B41FA5}">
                      <a16:colId xmlns:a16="http://schemas.microsoft.com/office/drawing/2014/main" val="1327398622"/>
                    </a:ext>
                  </a:extLst>
                </a:gridCol>
                <a:gridCol w="825922">
                  <a:extLst>
                    <a:ext uri="{9D8B030D-6E8A-4147-A177-3AD203B41FA5}">
                      <a16:colId xmlns:a16="http://schemas.microsoft.com/office/drawing/2014/main" val="613198028"/>
                    </a:ext>
                  </a:extLst>
                </a:gridCol>
                <a:gridCol w="1205656">
                  <a:extLst>
                    <a:ext uri="{9D8B030D-6E8A-4147-A177-3AD203B41FA5}">
                      <a16:colId xmlns:a16="http://schemas.microsoft.com/office/drawing/2014/main" val="532887542"/>
                    </a:ext>
                  </a:extLst>
                </a:gridCol>
              </a:tblGrid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 numbe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64857728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spero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6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0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89198556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A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0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9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47473675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G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2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18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6957527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8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07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083394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ROD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9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48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3061141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 (receptor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9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20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8655102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ur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5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6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129971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T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22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39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79868015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NP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2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0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2033332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t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6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36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7881236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t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4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0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9773128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Sy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5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9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35953510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x1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1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093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05347517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lu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1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14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54429331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N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1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25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9004194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RK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4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5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3094394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URK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29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202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14836647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AR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55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94341387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MB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4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1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99382069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RAS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3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75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135678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RB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62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61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00711626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fens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5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12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19895832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type lect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5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4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32003373"/>
                  </a:ext>
                </a:extLst>
              </a:tr>
              <a:tr h="1524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cropi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009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070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2073081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071EF807-A12B-926F-5A36-B6C0A92296DA}"/>
              </a:ext>
            </a:extLst>
          </p:cNvPr>
          <p:cNvSpPr txBox="1"/>
          <p:nvPr/>
        </p:nvSpPr>
        <p:spPr>
          <a:xfrm>
            <a:off x="540958" y="616659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40715042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D459CF0-F0C5-9F99-90DE-151327F5D4F0}"/>
              </a:ext>
            </a:extLst>
          </p:cNvPr>
          <p:cNvSpPr txBox="1"/>
          <p:nvPr/>
        </p:nvSpPr>
        <p:spPr>
          <a:xfrm>
            <a:off x="0" y="643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1DE6B4E-F5B5-C755-4BDB-D27E79BCAB0E}"/>
              </a:ext>
            </a:extLst>
          </p:cNvPr>
          <p:cNvSpPr txBox="1"/>
          <p:nvPr/>
        </p:nvSpPr>
        <p:spPr>
          <a:xfrm>
            <a:off x="1447877" y="661545"/>
            <a:ext cx="5543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dp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4655DE-9658-5619-E146-23755A033A7C}"/>
              </a:ext>
            </a:extLst>
          </p:cNvPr>
          <p:cNvSpPr txBox="1"/>
          <p:nvPr/>
        </p:nvSpPr>
        <p:spPr>
          <a:xfrm>
            <a:off x="4177053" y="661546"/>
            <a:ext cx="603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dpi</a:t>
            </a:r>
          </a:p>
        </p:txBody>
      </p:sp>
      <p:pic>
        <p:nvPicPr>
          <p:cNvPr id="8" name="Picture 7" descr="A close-up of a chart&#10;&#10;Description automatically generated">
            <a:extLst>
              <a:ext uri="{FF2B5EF4-FFF2-40B4-BE49-F238E27FC236}">
                <a16:creationId xmlns:a16="http://schemas.microsoft.com/office/drawing/2014/main" id="{253F2554-02DE-4467-6F39-39B185B3540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38544"/>
            <a:ext cx="6858000" cy="32657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04125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BDF5F1C-899A-936A-5817-99B123A7CACF}"/>
              </a:ext>
            </a:extLst>
          </p:cNvPr>
          <p:cNvSpPr txBox="1"/>
          <p:nvPr/>
        </p:nvSpPr>
        <p:spPr>
          <a:xfrm>
            <a:off x="0" y="643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5.</a:t>
            </a:r>
          </a:p>
        </p:txBody>
      </p:sp>
      <p:pic>
        <p:nvPicPr>
          <p:cNvPr id="4" name="Picture 3" descr="A graph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982E7805-A157-E8C0-AB16-A73CA8A440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3100" y="683138"/>
            <a:ext cx="5511800" cy="4356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01306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B800662D-9A60-C744-AAE9-02EF3619DB82}"/>
              </a:ext>
            </a:extLst>
          </p:cNvPr>
          <p:cNvSpPr txBox="1"/>
          <p:nvPr/>
        </p:nvSpPr>
        <p:spPr>
          <a:xfrm>
            <a:off x="0" y="68708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6.</a:t>
            </a:r>
          </a:p>
        </p:txBody>
      </p:sp>
      <p:pic>
        <p:nvPicPr>
          <p:cNvPr id="15" name="Picture 14" descr="A comparison of a number of numbers and a number of numbers&#10;&#10;Description automatically generated with medium confidence">
            <a:extLst>
              <a:ext uri="{FF2B5EF4-FFF2-40B4-BE49-F238E27FC236}">
                <a16:creationId xmlns:a16="http://schemas.microsoft.com/office/drawing/2014/main" id="{B0E2066C-4AF5-76D4-630D-AB429F251C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747186"/>
            <a:ext cx="5486400" cy="7315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6470579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416A4E7-D358-17D3-E862-8DB35D968E15}"/>
              </a:ext>
            </a:extLst>
          </p:cNvPr>
          <p:cNvSpPr txBox="1"/>
          <p:nvPr/>
        </p:nvSpPr>
        <p:spPr>
          <a:xfrm>
            <a:off x="0" y="643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7.</a:t>
            </a:r>
          </a:p>
        </p:txBody>
      </p:sp>
      <p:graphicFrame>
        <p:nvGraphicFramePr>
          <p:cNvPr id="17" name="Table 16">
            <a:extLst>
              <a:ext uri="{FF2B5EF4-FFF2-40B4-BE49-F238E27FC236}">
                <a16:creationId xmlns:a16="http://schemas.microsoft.com/office/drawing/2014/main" id="{CCFA5758-A1B8-2039-E883-038C9058587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17962015"/>
              </p:ext>
            </p:extLst>
          </p:nvPr>
        </p:nvGraphicFramePr>
        <p:xfrm>
          <a:off x="1778000" y="7496696"/>
          <a:ext cx="3301999" cy="3048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084">
                  <a:extLst>
                    <a:ext uri="{9D8B030D-6E8A-4147-A177-3AD203B41FA5}">
                      <a16:colId xmlns:a16="http://schemas.microsoft.com/office/drawing/2014/main" val="3140000331"/>
                    </a:ext>
                  </a:extLst>
                </a:gridCol>
                <a:gridCol w="827084">
                  <a:extLst>
                    <a:ext uri="{9D8B030D-6E8A-4147-A177-3AD203B41FA5}">
                      <a16:colId xmlns:a16="http://schemas.microsoft.com/office/drawing/2014/main" val="724730111"/>
                    </a:ext>
                  </a:extLst>
                </a:gridCol>
                <a:gridCol w="1647831">
                  <a:extLst>
                    <a:ext uri="{9D8B030D-6E8A-4147-A177-3AD203B41FA5}">
                      <a16:colId xmlns:a16="http://schemas.microsoft.com/office/drawing/2014/main" val="805425635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 Numbe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3752645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21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cp-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05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022763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8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edd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EL01414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363847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93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10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3948831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167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p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1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669161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4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rviv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669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8359166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7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75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5171231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7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5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36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3906372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31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n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9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3999236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403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on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29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9502440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10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m-1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090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4993324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17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g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1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73827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387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rg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18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5247076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877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ck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25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8019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482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ck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425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52430432"/>
                  </a:ext>
                </a:extLst>
              </a:tr>
            </a:tbl>
          </a:graphicData>
        </a:graphic>
      </p:graphicFrame>
      <p:grpSp>
        <p:nvGrpSpPr>
          <p:cNvPr id="38" name="Group 37">
            <a:extLst>
              <a:ext uri="{FF2B5EF4-FFF2-40B4-BE49-F238E27FC236}">
                <a16:creationId xmlns:a16="http://schemas.microsoft.com/office/drawing/2014/main" id="{02C7AF17-2F0D-A9DE-B944-B298F21B8F8D}"/>
              </a:ext>
            </a:extLst>
          </p:cNvPr>
          <p:cNvGrpSpPr/>
          <p:nvPr/>
        </p:nvGrpSpPr>
        <p:grpSpPr>
          <a:xfrm>
            <a:off x="0" y="428104"/>
            <a:ext cx="6858000" cy="6858000"/>
            <a:chOff x="0" y="428104"/>
            <a:chExt cx="6858000" cy="6858000"/>
          </a:xfrm>
        </p:grpSpPr>
        <p:pic>
          <p:nvPicPr>
            <p:cNvPr id="16" name="Picture 15" descr="A screenshot of a graph&#10;&#10;Description automatically generated">
              <a:extLst>
                <a:ext uri="{FF2B5EF4-FFF2-40B4-BE49-F238E27FC236}">
                  <a16:creationId xmlns:a16="http://schemas.microsoft.com/office/drawing/2014/main" id="{D299A855-9ADF-DDC9-326A-3AC175EB14A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428104"/>
              <a:ext cx="6858000" cy="6858000"/>
            </a:xfrm>
            <a:prstGeom prst="rect">
              <a:avLst/>
            </a:prstGeom>
          </p:spPr>
        </p:pic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496A91B9-6F61-A8CE-51B4-1F6443C5B730}"/>
                </a:ext>
              </a:extLst>
            </p:cNvPr>
            <p:cNvSpPr/>
            <p:nvPr/>
          </p:nvSpPr>
          <p:spPr>
            <a:xfrm>
              <a:off x="499730" y="428104"/>
              <a:ext cx="5932968" cy="2311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547E82C-82F5-37EA-5D5D-B0782D6F03D1}"/>
                </a:ext>
              </a:extLst>
            </p:cNvPr>
            <p:cNvSpPr txBox="1"/>
            <p:nvPr/>
          </p:nvSpPr>
          <p:spPr>
            <a:xfrm>
              <a:off x="597706" y="428104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CP-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4CAAE755-3A7E-1225-388C-FCCE1DE552AA}"/>
                </a:ext>
              </a:extLst>
            </p:cNvPr>
            <p:cNvSpPr txBox="1"/>
            <p:nvPr/>
          </p:nvSpPr>
          <p:spPr>
            <a:xfrm>
              <a:off x="2387520" y="428104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redd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7043A265-0363-D732-7AA9-DE64FDFF4DEB}"/>
                </a:ext>
              </a:extLst>
            </p:cNvPr>
            <p:cNvSpPr txBox="1"/>
            <p:nvPr/>
          </p:nvSpPr>
          <p:spPr>
            <a:xfrm>
              <a:off x="4005638" y="428104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iap-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924EF9C-0764-B943-8086-D4A8C41FE5D8}"/>
                </a:ext>
              </a:extLst>
            </p:cNvPr>
            <p:cNvSpPr txBox="1"/>
            <p:nvPr/>
          </p:nvSpPr>
          <p:spPr>
            <a:xfrm>
              <a:off x="5697109" y="428104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iap-1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FC7465E2-22D2-AB1D-E078-D3FB9FEFB422}"/>
                </a:ext>
              </a:extLst>
            </p:cNvPr>
            <p:cNvSpPr/>
            <p:nvPr/>
          </p:nvSpPr>
          <p:spPr>
            <a:xfrm>
              <a:off x="499730" y="2122225"/>
              <a:ext cx="5932968" cy="2311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62296C9-1799-5BF2-E16B-E34A557746D2}"/>
                </a:ext>
              </a:extLst>
            </p:cNvPr>
            <p:cNvSpPr txBox="1"/>
            <p:nvPr/>
          </p:nvSpPr>
          <p:spPr>
            <a:xfrm>
              <a:off x="597705" y="2175760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urvivin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C46D82A0-6081-CC6B-199E-9387B0D67BF7}"/>
                </a:ext>
              </a:extLst>
            </p:cNvPr>
            <p:cNvSpPr txBox="1"/>
            <p:nvPr/>
          </p:nvSpPr>
          <p:spPr>
            <a:xfrm>
              <a:off x="2268989" y="2175760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738D14B-8701-356F-82DA-410498D4642A}"/>
                </a:ext>
              </a:extLst>
            </p:cNvPr>
            <p:cNvSpPr txBox="1"/>
            <p:nvPr/>
          </p:nvSpPr>
          <p:spPr>
            <a:xfrm>
              <a:off x="4005637" y="2175760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635E28F-79A1-3B3A-1FBC-F75F5AEB18EE}"/>
                </a:ext>
              </a:extLst>
            </p:cNvPr>
            <p:cNvSpPr txBox="1"/>
            <p:nvPr/>
          </p:nvSpPr>
          <p:spPr>
            <a:xfrm>
              <a:off x="5596579" y="2175760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ronc</a:t>
              </a: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C3E2636A-1F11-17D7-DF25-F2CD2EE6F785}"/>
                </a:ext>
              </a:extLst>
            </p:cNvPr>
            <p:cNvSpPr/>
            <p:nvPr/>
          </p:nvSpPr>
          <p:spPr>
            <a:xfrm>
              <a:off x="462515" y="3820262"/>
              <a:ext cx="5932968" cy="2311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C3E50E8-CBA8-8103-E641-4859A6204CB8}"/>
                </a:ext>
              </a:extLst>
            </p:cNvPr>
            <p:cNvSpPr txBox="1"/>
            <p:nvPr/>
          </p:nvSpPr>
          <p:spPr>
            <a:xfrm>
              <a:off x="597704" y="3850757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ronc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E30C8FE-1001-23EF-11D9-9FAFB0594FCD}"/>
                </a:ext>
              </a:extLst>
            </p:cNvPr>
            <p:cNvSpPr txBox="1"/>
            <p:nvPr/>
          </p:nvSpPr>
          <p:spPr>
            <a:xfrm>
              <a:off x="2268988" y="3850757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rim-19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E455E45-B91E-C07C-8020-262B595ED01B}"/>
                </a:ext>
              </a:extLst>
            </p:cNvPr>
            <p:cNvSpPr txBox="1"/>
            <p:nvPr/>
          </p:nvSpPr>
          <p:spPr>
            <a:xfrm>
              <a:off x="4005636" y="3850757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orgue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69BE831-7593-7DE0-0474-668C441EE375}"/>
                </a:ext>
              </a:extLst>
            </p:cNvPr>
            <p:cNvSpPr txBox="1"/>
            <p:nvPr/>
          </p:nvSpPr>
          <p:spPr>
            <a:xfrm>
              <a:off x="5594472" y="3851053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orgue</a:t>
              </a:r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6BF921E6-04AF-A463-DB51-9E29A14879F2}"/>
                </a:ext>
              </a:extLst>
            </p:cNvPr>
            <p:cNvSpPr/>
            <p:nvPr/>
          </p:nvSpPr>
          <p:spPr>
            <a:xfrm>
              <a:off x="182727" y="5522540"/>
              <a:ext cx="5932968" cy="2311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6DBDFC5-CB75-5715-31E8-74A1C34A50A7}"/>
                </a:ext>
              </a:extLst>
            </p:cNvPr>
            <p:cNvSpPr txBox="1"/>
            <p:nvPr/>
          </p:nvSpPr>
          <p:spPr>
            <a:xfrm>
              <a:off x="574158" y="5522540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ickle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A4BE6572-77BF-95F7-F937-B7D410E47041}"/>
                </a:ext>
              </a:extLst>
            </p:cNvPr>
            <p:cNvSpPr txBox="1"/>
            <p:nvPr/>
          </p:nvSpPr>
          <p:spPr>
            <a:xfrm>
              <a:off x="2268987" y="5522540"/>
              <a:ext cx="76169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ickl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759298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113F47B-9443-E206-3E8D-A39007A0553D}"/>
              </a:ext>
            </a:extLst>
          </p:cNvPr>
          <p:cNvSpPr txBox="1"/>
          <p:nvPr/>
        </p:nvSpPr>
        <p:spPr>
          <a:xfrm>
            <a:off x="0" y="643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8.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0D50D837-6937-859B-06F1-6555CB962228}"/>
              </a:ext>
            </a:extLst>
          </p:cNvPr>
          <p:cNvGrpSpPr/>
          <p:nvPr/>
        </p:nvGrpSpPr>
        <p:grpSpPr>
          <a:xfrm>
            <a:off x="996663" y="599823"/>
            <a:ext cx="4864673" cy="5847292"/>
            <a:chOff x="998655" y="1108708"/>
            <a:chExt cx="4860689" cy="6075850"/>
          </a:xfrm>
        </p:grpSpPr>
        <p:pic>
          <p:nvPicPr>
            <p:cNvPr id="9" name="Picture 8" descr="A group of maps with numbers and symbols&#10;&#10;Description automatically generated with medium confidence">
              <a:extLst>
                <a:ext uri="{FF2B5EF4-FFF2-40B4-BE49-F238E27FC236}">
                  <a16:creationId xmlns:a16="http://schemas.microsoft.com/office/drawing/2014/main" id="{7FB76FD3-A83D-CEAA-8EB8-A7C1F0F64D1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98655" y="1108708"/>
              <a:ext cx="4860689" cy="607585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A7EB89C-7127-2A75-5C3C-32DC02351604}"/>
                </a:ext>
              </a:extLst>
            </p:cNvPr>
            <p:cNvSpPr txBox="1"/>
            <p:nvPr/>
          </p:nvSpPr>
          <p:spPr>
            <a:xfrm>
              <a:off x="1839441" y="1108708"/>
              <a:ext cx="761067" cy="2616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DC45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3FA85091-4D01-FA0F-268D-1CC022511B3C}"/>
                </a:ext>
              </a:extLst>
            </p:cNvPr>
            <p:cNvSpPr txBox="1"/>
            <p:nvPr/>
          </p:nvSpPr>
          <p:spPr>
            <a:xfrm>
              <a:off x="4257494" y="1108708"/>
              <a:ext cx="761067" cy="2616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CM5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F35D924-92AE-EA59-5A99-688D26FC8F29}"/>
                </a:ext>
              </a:extLst>
            </p:cNvPr>
            <p:cNvSpPr txBox="1"/>
            <p:nvPr/>
          </p:nvSpPr>
          <p:spPr>
            <a:xfrm>
              <a:off x="1839441" y="3121300"/>
              <a:ext cx="761067" cy="2616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CM6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0B7EB8B-7641-0C54-E754-6B3D7E6C682E}"/>
                </a:ext>
              </a:extLst>
            </p:cNvPr>
            <p:cNvSpPr txBox="1"/>
            <p:nvPr/>
          </p:nvSpPr>
          <p:spPr>
            <a:xfrm>
              <a:off x="4257494" y="3121300"/>
              <a:ext cx="761067" cy="2616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HAF1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7B23BE1-B771-32F5-540B-A32AF2C471CF}"/>
                </a:ext>
              </a:extLst>
            </p:cNvPr>
            <p:cNvSpPr txBox="1"/>
            <p:nvPr/>
          </p:nvSpPr>
          <p:spPr>
            <a:xfrm>
              <a:off x="1839440" y="5152938"/>
              <a:ext cx="761067" cy="26160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YMS</a:t>
              </a:r>
            </a:p>
          </p:txBody>
        </p:sp>
      </p:grp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D62A448F-AB44-CF47-761A-6A1D81D143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5777837"/>
              </p:ext>
            </p:extLst>
          </p:nvPr>
        </p:nvGraphicFramePr>
        <p:xfrm>
          <a:off x="1660937" y="6931360"/>
          <a:ext cx="3536123" cy="12192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084">
                  <a:extLst>
                    <a:ext uri="{9D8B030D-6E8A-4147-A177-3AD203B41FA5}">
                      <a16:colId xmlns:a16="http://schemas.microsoft.com/office/drawing/2014/main" val="445349134"/>
                    </a:ext>
                  </a:extLst>
                </a:gridCol>
                <a:gridCol w="827084">
                  <a:extLst>
                    <a:ext uri="{9D8B030D-6E8A-4147-A177-3AD203B41FA5}">
                      <a16:colId xmlns:a16="http://schemas.microsoft.com/office/drawing/2014/main" val="1645864113"/>
                    </a:ext>
                  </a:extLst>
                </a:gridCol>
                <a:gridCol w="1881955">
                  <a:extLst>
                    <a:ext uri="{9D8B030D-6E8A-4147-A177-3AD203B41FA5}">
                      <a16:colId xmlns:a16="http://schemas.microsoft.com/office/drawing/2014/main" val="2065286540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ID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ession Numbe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5757216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780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c4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179, CPIJ0044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30531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15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m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HJ7376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931526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21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m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0904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76325053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5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f1b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X6659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210753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956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ms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IJ01135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420783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97241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9</TotalTime>
  <Words>1944</Words>
  <Application>Microsoft Macintosh PowerPoint</Application>
  <PresentationFormat>Custom</PresentationFormat>
  <Paragraphs>1549</Paragraphs>
  <Slides>1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4" baseType="lpstr">
      <vt:lpstr>Aptos</vt:lpstr>
      <vt:lpstr>Aptos Display</vt:lpstr>
      <vt:lpstr>Arial</vt:lpstr>
      <vt:lpstr>Arial Narro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itzmeyer,Emily</dc:creator>
  <cp:lastModifiedBy>Fitzmeyer,Emily</cp:lastModifiedBy>
  <cp:revision>102</cp:revision>
  <dcterms:created xsi:type="dcterms:W3CDTF">2024-07-08T20:10:11Z</dcterms:created>
  <dcterms:modified xsi:type="dcterms:W3CDTF">2024-11-01T18:06:57Z</dcterms:modified>
</cp:coreProperties>
</file>